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8280400" cy="6300788"/>
  <p:notesSz cx="6858000" cy="9144000"/>
  <p:defaultTextStyle>
    <a:defPPr>
      <a:defRPr lang="pt-PT"/>
    </a:defPPr>
    <a:lvl1pPr marL="0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1pPr>
    <a:lvl2pPr marL="426659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2pPr>
    <a:lvl3pPr marL="853318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3pPr>
    <a:lvl4pPr marL="1279977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4pPr>
    <a:lvl5pPr marL="1706636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5pPr>
    <a:lvl6pPr marL="2133295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6pPr>
    <a:lvl7pPr marL="2559954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7pPr>
    <a:lvl8pPr marL="2986613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8pPr>
    <a:lvl9pPr marL="3413272" algn="l" defTabSz="853318" rtl="0" eaLnBrk="1" latinLnBrk="0" hangingPunct="1">
      <a:defRPr sz="168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1512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0" y="1031171"/>
            <a:ext cx="7038340" cy="2193608"/>
          </a:xfrm>
        </p:spPr>
        <p:txBody>
          <a:bodyPr anchor="b"/>
          <a:lstStyle>
            <a:lvl1pPr algn="ctr">
              <a:defRPr sz="54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0" y="3309373"/>
            <a:ext cx="6210300" cy="1521231"/>
          </a:xfrm>
        </p:spPr>
        <p:txBody>
          <a:bodyPr/>
          <a:lstStyle>
            <a:lvl1pPr marL="0" indent="0" algn="ctr">
              <a:buNone/>
              <a:defRPr sz="2173"/>
            </a:lvl1pPr>
            <a:lvl2pPr marL="414040" indent="0" algn="ctr">
              <a:buNone/>
              <a:defRPr sz="1811"/>
            </a:lvl2pPr>
            <a:lvl3pPr marL="828081" indent="0" algn="ctr">
              <a:buNone/>
              <a:defRPr sz="1630"/>
            </a:lvl3pPr>
            <a:lvl4pPr marL="1242121" indent="0" algn="ctr">
              <a:buNone/>
              <a:defRPr sz="1449"/>
            </a:lvl4pPr>
            <a:lvl5pPr marL="1656161" indent="0" algn="ctr">
              <a:buNone/>
              <a:defRPr sz="1449"/>
            </a:lvl5pPr>
            <a:lvl6pPr marL="2070202" indent="0" algn="ctr">
              <a:buNone/>
              <a:defRPr sz="1449"/>
            </a:lvl6pPr>
            <a:lvl7pPr marL="2484242" indent="0" algn="ctr">
              <a:buNone/>
              <a:defRPr sz="1449"/>
            </a:lvl7pPr>
            <a:lvl8pPr marL="2898282" indent="0" algn="ctr">
              <a:buNone/>
              <a:defRPr sz="1449"/>
            </a:lvl8pPr>
            <a:lvl9pPr marL="3312323" indent="0" algn="ctr">
              <a:buNone/>
              <a:defRPr sz="1449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38150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14461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2" y="335458"/>
            <a:ext cx="1785461" cy="53396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8" y="335458"/>
            <a:ext cx="5252879" cy="533962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05577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01203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5" y="1570823"/>
            <a:ext cx="7141845" cy="2620952"/>
          </a:xfrm>
        </p:spPr>
        <p:txBody>
          <a:bodyPr anchor="b"/>
          <a:lstStyle>
            <a:lvl1pPr>
              <a:defRPr sz="54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5" y="4216571"/>
            <a:ext cx="7141845" cy="1378297"/>
          </a:xfrm>
        </p:spPr>
        <p:txBody>
          <a:bodyPr/>
          <a:lstStyle>
            <a:lvl1pPr marL="0" indent="0">
              <a:buNone/>
              <a:defRPr sz="2173">
                <a:solidFill>
                  <a:schemeClr val="tx1"/>
                </a:solidFill>
              </a:defRPr>
            </a:lvl1pPr>
            <a:lvl2pPr marL="414040" indent="0">
              <a:buNone/>
              <a:defRPr sz="1811">
                <a:solidFill>
                  <a:schemeClr val="tx1">
                    <a:tint val="75000"/>
                  </a:schemeClr>
                </a:solidFill>
              </a:defRPr>
            </a:lvl2pPr>
            <a:lvl3pPr marL="82808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3pPr>
            <a:lvl4pPr marL="124212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4pPr>
            <a:lvl5pPr marL="165616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5pPr>
            <a:lvl6pPr marL="207020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6pPr>
            <a:lvl7pPr marL="248424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7pPr>
            <a:lvl8pPr marL="289828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8pPr>
            <a:lvl9pPr marL="3312323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62192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1677293"/>
            <a:ext cx="3519170" cy="39977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1677293"/>
            <a:ext cx="3519170" cy="399779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68179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335460"/>
            <a:ext cx="7141845" cy="121786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7" y="1544569"/>
            <a:ext cx="3502997" cy="756969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7" y="2301538"/>
            <a:ext cx="3502997" cy="338521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3" y="1544569"/>
            <a:ext cx="3520249" cy="756969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3" y="2301538"/>
            <a:ext cx="3520249" cy="338521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52625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84152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05528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20052"/>
            <a:ext cx="2670645" cy="1470184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8" y="907198"/>
            <a:ext cx="4191953" cy="4477643"/>
          </a:xfrm>
        </p:spPr>
        <p:txBody>
          <a:bodyPr/>
          <a:lstStyle>
            <a:lvl1pPr>
              <a:defRPr sz="2898"/>
            </a:lvl1pPr>
            <a:lvl2pPr>
              <a:defRPr sz="2536"/>
            </a:lvl2pPr>
            <a:lvl3pPr>
              <a:defRPr sz="2173"/>
            </a:lvl3pPr>
            <a:lvl4pPr>
              <a:defRPr sz="1811"/>
            </a:lvl4pPr>
            <a:lvl5pPr>
              <a:defRPr sz="1811"/>
            </a:lvl5pPr>
            <a:lvl6pPr>
              <a:defRPr sz="1811"/>
            </a:lvl6pPr>
            <a:lvl7pPr>
              <a:defRPr sz="1811"/>
            </a:lvl7pPr>
            <a:lvl8pPr>
              <a:defRPr sz="1811"/>
            </a:lvl8pPr>
            <a:lvl9pPr>
              <a:defRPr sz="181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1890236"/>
            <a:ext cx="2670645" cy="3501897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91355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20052"/>
            <a:ext cx="2670645" cy="1470184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8" y="907198"/>
            <a:ext cx="4191953" cy="4477643"/>
          </a:xfrm>
        </p:spPr>
        <p:txBody>
          <a:bodyPr anchor="t"/>
          <a:lstStyle>
            <a:lvl1pPr marL="0" indent="0">
              <a:buNone/>
              <a:defRPr sz="2898"/>
            </a:lvl1pPr>
            <a:lvl2pPr marL="414040" indent="0">
              <a:buNone/>
              <a:defRPr sz="2536"/>
            </a:lvl2pPr>
            <a:lvl3pPr marL="828081" indent="0">
              <a:buNone/>
              <a:defRPr sz="2173"/>
            </a:lvl3pPr>
            <a:lvl4pPr marL="1242121" indent="0">
              <a:buNone/>
              <a:defRPr sz="1811"/>
            </a:lvl4pPr>
            <a:lvl5pPr marL="1656161" indent="0">
              <a:buNone/>
              <a:defRPr sz="1811"/>
            </a:lvl5pPr>
            <a:lvl6pPr marL="2070202" indent="0">
              <a:buNone/>
              <a:defRPr sz="1811"/>
            </a:lvl6pPr>
            <a:lvl7pPr marL="2484242" indent="0">
              <a:buNone/>
              <a:defRPr sz="1811"/>
            </a:lvl7pPr>
            <a:lvl8pPr marL="2898282" indent="0">
              <a:buNone/>
              <a:defRPr sz="1811"/>
            </a:lvl8pPr>
            <a:lvl9pPr marL="3312323" indent="0">
              <a:buNone/>
              <a:defRPr sz="1811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1890236"/>
            <a:ext cx="2670645" cy="3501897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31708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335460"/>
            <a:ext cx="7141845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1677293"/>
            <a:ext cx="7141845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8" y="5839898"/>
            <a:ext cx="1863090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04BF2-2B3B-4618-AF0A-FF9661B83824}" type="datetimeFigureOut">
              <a:rPr lang="pt-PT" smtClean="0"/>
              <a:t>30/01/2019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5839898"/>
            <a:ext cx="2794635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5839898"/>
            <a:ext cx="1863090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839EC-A923-4F2E-B6C2-3840F3F957D3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0031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28081" rtl="0" eaLnBrk="1" latinLnBrk="0" hangingPunct="1">
        <a:lnSpc>
          <a:spcPct val="90000"/>
        </a:lnSpc>
        <a:spcBef>
          <a:spcPct val="0"/>
        </a:spcBef>
        <a:buNone/>
        <a:defRPr sz="39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7020" indent="-207020" algn="l" defTabSz="828081" rtl="0" eaLnBrk="1" latinLnBrk="0" hangingPunct="1">
        <a:lnSpc>
          <a:spcPct val="90000"/>
        </a:lnSpc>
        <a:spcBef>
          <a:spcPts val="906"/>
        </a:spcBef>
        <a:buFont typeface="Arial" panose="020B0604020202020204" pitchFamily="34" charset="0"/>
        <a:buChar char="•"/>
        <a:defRPr sz="2536" kern="1200">
          <a:solidFill>
            <a:schemeClr val="tx1"/>
          </a:solidFill>
          <a:latin typeface="+mn-lt"/>
          <a:ea typeface="+mn-ea"/>
          <a:cs typeface="+mn-cs"/>
        </a:defRPr>
      </a:lvl1pPr>
      <a:lvl2pPr marL="621060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03510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811" kern="1200">
          <a:solidFill>
            <a:schemeClr val="tx1"/>
          </a:solidFill>
          <a:latin typeface="+mn-lt"/>
          <a:ea typeface="+mn-ea"/>
          <a:cs typeface="+mn-cs"/>
        </a:defRPr>
      </a:lvl3pPr>
      <a:lvl4pPr marL="144914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86318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27722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69126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310530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519343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1pPr>
      <a:lvl2pPr marL="41404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2pPr>
      <a:lvl3pPr marL="82808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3pPr>
      <a:lvl4pPr marL="124212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65616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07020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48424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289828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312323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/>
          <p:cNvGrpSpPr/>
          <p:nvPr/>
        </p:nvGrpSpPr>
        <p:grpSpPr>
          <a:xfrm>
            <a:off x="550600" y="0"/>
            <a:ext cx="7560840" cy="6120680"/>
            <a:chOff x="611560" y="404664"/>
            <a:chExt cx="7560840" cy="6120680"/>
          </a:xfrm>
        </p:grpSpPr>
        <p:sp>
          <p:nvSpPr>
            <p:cNvPr id="83" name="Rectangle 82"/>
            <p:cNvSpPr/>
            <p:nvPr/>
          </p:nvSpPr>
          <p:spPr>
            <a:xfrm>
              <a:off x="611560" y="404664"/>
              <a:ext cx="7560840" cy="61206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grpSp>
          <p:nvGrpSpPr>
            <p:cNvPr id="84" name="Group 83"/>
            <p:cNvGrpSpPr/>
            <p:nvPr/>
          </p:nvGrpSpPr>
          <p:grpSpPr>
            <a:xfrm>
              <a:off x="670847" y="476672"/>
              <a:ext cx="7192320" cy="5920406"/>
              <a:chOff x="670847" y="476672"/>
              <a:chExt cx="7192320" cy="5920406"/>
            </a:xfrm>
          </p:grpSpPr>
          <p:pic>
            <p:nvPicPr>
              <p:cNvPr id="85" name="Picture 4" descr="C:\Documents and Settings\TCA\Desktop\Presto_DIF15_Average.tif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b="35371"/>
              <a:stretch>
                <a:fillRect/>
              </a:stretch>
            </p:blipFill>
            <p:spPr bwMode="auto">
              <a:xfrm>
                <a:off x="1898324" y="476672"/>
                <a:ext cx="4761908" cy="2772000"/>
              </a:xfrm>
              <a:prstGeom prst="rect">
                <a:avLst/>
              </a:prstGeom>
              <a:noFill/>
            </p:spPr>
          </p:pic>
          <p:sp>
            <p:nvSpPr>
              <p:cNvPr id="86" name="Rectangle 85"/>
              <p:cNvSpPr/>
              <p:nvPr/>
            </p:nvSpPr>
            <p:spPr>
              <a:xfrm>
                <a:off x="1082290" y="5056744"/>
                <a:ext cx="359596" cy="118800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rgbClr val="0066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PT" sz="160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670847" y="529516"/>
                <a:ext cx="5040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PT" sz="2800" b="1" dirty="0" smtClean="0"/>
                  <a:t>A</a:t>
                </a:r>
                <a:endParaRPr lang="pt-PT" sz="2800" b="1" dirty="0"/>
              </a:p>
            </p:txBody>
          </p:sp>
          <p:sp>
            <p:nvSpPr>
              <p:cNvPr id="88" name="CaixaDeTexto 4"/>
              <p:cNvSpPr txBox="1"/>
              <p:nvPr/>
            </p:nvSpPr>
            <p:spPr>
              <a:xfrm>
                <a:off x="3098867" y="3436456"/>
                <a:ext cx="15841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1400" dirty="0" err="1"/>
                  <a:t>Post</a:t>
                </a:r>
                <a:r>
                  <a:rPr lang="pt-PT" sz="1400" dirty="0"/>
                  <a:t> </a:t>
                </a:r>
                <a:r>
                  <a:rPr lang="pt-PT" sz="1400" dirty="0" err="1"/>
                  <a:t>Ischemia</a:t>
                </a:r>
                <a:endParaRPr lang="pt-PT" sz="1400" dirty="0"/>
              </a:p>
            </p:txBody>
          </p:sp>
          <p:sp>
            <p:nvSpPr>
              <p:cNvPr id="89" name="CaixaDeTexto 5"/>
              <p:cNvSpPr txBox="1"/>
              <p:nvPr/>
            </p:nvSpPr>
            <p:spPr>
              <a:xfrm>
                <a:off x="4685351" y="3328734"/>
                <a:ext cx="158417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1400" dirty="0"/>
                  <a:t>1h P</a:t>
                </a:r>
                <a:r>
                  <a:rPr lang="pt-PT" sz="1400" dirty="0" smtClean="0"/>
                  <a:t>ost </a:t>
                </a:r>
                <a:r>
                  <a:rPr lang="pt-PT" sz="1400" dirty="0"/>
                  <a:t>Reperfusion</a:t>
                </a:r>
              </a:p>
            </p:txBody>
          </p:sp>
          <p:sp>
            <p:nvSpPr>
              <p:cNvPr id="90" name="CaixaDeTexto 6"/>
              <p:cNvSpPr txBox="1"/>
              <p:nvPr/>
            </p:nvSpPr>
            <p:spPr>
              <a:xfrm>
                <a:off x="6278991" y="3328734"/>
                <a:ext cx="158417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1400" dirty="0"/>
                  <a:t>16h P</a:t>
                </a:r>
                <a:r>
                  <a:rPr lang="pt-PT" sz="1400" dirty="0" smtClean="0"/>
                  <a:t>ost </a:t>
                </a:r>
                <a:r>
                  <a:rPr lang="pt-PT" sz="1400" dirty="0"/>
                  <a:t>Reperfusion</a:t>
                </a:r>
              </a:p>
            </p:txBody>
          </p:sp>
          <p:sp>
            <p:nvSpPr>
              <p:cNvPr id="91" name="CaixaDeTexto 23"/>
              <p:cNvSpPr txBox="1"/>
              <p:nvPr/>
            </p:nvSpPr>
            <p:spPr>
              <a:xfrm>
                <a:off x="1492453" y="3436456"/>
                <a:ext cx="15841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1400" dirty="0" err="1"/>
                  <a:t>Before</a:t>
                </a:r>
                <a:r>
                  <a:rPr lang="pt-PT" sz="1400" dirty="0"/>
                  <a:t> </a:t>
                </a:r>
                <a:r>
                  <a:rPr lang="pt-PT" sz="1400" dirty="0" err="1"/>
                  <a:t>Insult</a:t>
                </a:r>
                <a:endParaRPr lang="pt-PT" sz="1400" dirty="0"/>
              </a:p>
            </p:txBody>
          </p:sp>
          <p:pic>
            <p:nvPicPr>
              <p:cNvPr id="92" name="Imagem 1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02290" y="3832159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3" name="Imagem 1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92758" y="3832159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4" name="Imagem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95936" y="3832159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5" name="Imagem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99113" y="3832159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6" name="Imagem 4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95936" y="5067761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7" name="Imagem 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92758" y="5067761"/>
                <a:ext cx="1566380" cy="1170000"/>
              </a:xfrm>
              <a:prstGeom prst="rect">
                <a:avLst/>
              </a:prstGeom>
            </p:spPr>
          </p:pic>
          <p:pic>
            <p:nvPicPr>
              <p:cNvPr id="98" name="Imagem 2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99113" y="5067761"/>
                <a:ext cx="1566380" cy="1170000"/>
              </a:xfrm>
              <a:prstGeom prst="rect">
                <a:avLst/>
              </a:prstGeom>
            </p:spPr>
          </p:pic>
          <p:sp>
            <p:nvSpPr>
              <p:cNvPr id="99" name="Rectangle 98"/>
              <p:cNvSpPr/>
              <p:nvPr/>
            </p:nvSpPr>
            <p:spPr>
              <a:xfrm>
                <a:off x="1082290" y="3832669"/>
                <a:ext cx="359596" cy="118800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PT" sz="1600"/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1046645" y="5056744"/>
                <a:ext cx="430887" cy="1188000"/>
              </a:xfrm>
              <a:prstGeom prst="rect">
                <a:avLst/>
              </a:prstGeom>
              <a:noFill/>
            </p:spPr>
            <p:txBody>
              <a:bodyPr vert="vert270" wrap="square" rtlCol="0" anchor="ctr">
                <a:spAutoFit/>
              </a:bodyPr>
              <a:lstStyle/>
              <a:p>
                <a:pPr algn="ctr"/>
                <a:r>
                  <a:rPr lang="pt-PT" sz="1600" dirty="0"/>
                  <a:t>Co CM i</a:t>
                </a:r>
              </a:p>
            </p:txBody>
          </p:sp>
          <p:cxnSp>
            <p:nvCxnSpPr>
              <p:cNvPr id="101" name="Conexão reta 24"/>
              <p:cNvCxnSpPr/>
              <p:nvPr/>
            </p:nvCxnSpPr>
            <p:spPr>
              <a:xfrm>
                <a:off x="3085569" y="3337078"/>
                <a:ext cx="0" cy="306000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exão reta 21"/>
              <p:cNvCxnSpPr/>
              <p:nvPr/>
            </p:nvCxnSpPr>
            <p:spPr>
              <a:xfrm>
                <a:off x="4679997" y="3337078"/>
                <a:ext cx="0" cy="306000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Conexão reta 22"/>
              <p:cNvCxnSpPr/>
              <p:nvPr/>
            </p:nvCxnSpPr>
            <p:spPr>
              <a:xfrm>
                <a:off x="6272883" y="3337078"/>
                <a:ext cx="0" cy="306000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4" name="TextBox 103"/>
              <p:cNvSpPr txBox="1"/>
              <p:nvPr/>
            </p:nvSpPr>
            <p:spPr>
              <a:xfrm>
                <a:off x="1046645" y="3832669"/>
                <a:ext cx="430887" cy="1188000"/>
              </a:xfrm>
              <a:prstGeom prst="rect">
                <a:avLst/>
              </a:prstGeom>
              <a:noFill/>
            </p:spPr>
            <p:txBody>
              <a:bodyPr vert="vert270" wrap="square" rtlCol="0" anchor="ctr">
                <a:spAutoFit/>
              </a:bodyPr>
              <a:lstStyle/>
              <a:p>
                <a:pPr algn="ctr"/>
                <a:r>
                  <a:rPr lang="pt-PT" sz="1600" dirty="0"/>
                  <a:t>M CM i</a:t>
                </a:r>
              </a:p>
            </p:txBody>
          </p:sp>
          <p:pic>
            <p:nvPicPr>
              <p:cNvPr id="105" name="Picture 2" descr="D:\Users\MJS\PHD\resultados\2015.09.21_INSULT_hCMSdifday15\FOTOS_FDAPI_2015.09.21\F_BI.tif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502670" y="5067761"/>
                <a:ext cx="1566000" cy="1170000"/>
              </a:xfrm>
              <a:prstGeom prst="rect">
                <a:avLst/>
              </a:prstGeom>
              <a:noFill/>
            </p:spPr>
          </p:pic>
          <p:grpSp>
            <p:nvGrpSpPr>
              <p:cNvPr id="106" name="Group 105"/>
              <p:cNvGrpSpPr/>
              <p:nvPr/>
            </p:nvGrpSpPr>
            <p:grpSpPr>
              <a:xfrm>
                <a:off x="4767627" y="681679"/>
                <a:ext cx="1035538" cy="497671"/>
                <a:chOff x="6012160" y="1318734"/>
                <a:chExt cx="1035538" cy="497671"/>
              </a:xfrm>
            </p:grpSpPr>
            <p:pic>
              <p:nvPicPr>
                <p:cNvPr id="110" name="Picture 109" descr="Presto_MAT10_Average2.tif"/>
                <p:cNvPicPr>
                  <a:picLocks noChangeAspect="1"/>
                </p:cNvPicPr>
                <p:nvPr/>
              </p:nvPicPr>
              <p:blipFill>
                <a:blip r:embed="rId11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78115" t="24043" r="1581" b="63145"/>
                <a:stretch>
                  <a:fillRect/>
                </a:stretch>
              </p:blipFill>
              <p:spPr>
                <a:xfrm>
                  <a:off x="6012160" y="1484784"/>
                  <a:ext cx="1035538" cy="331621"/>
                </a:xfrm>
                <a:prstGeom prst="rect">
                  <a:avLst/>
                </a:prstGeom>
              </p:spPr>
            </p:pic>
            <p:pic>
              <p:nvPicPr>
                <p:cNvPr id="111" name="Picture 110" descr="Presto_MAT10_Average2.tif"/>
                <p:cNvPicPr>
                  <a:picLocks noChangeAspect="1"/>
                </p:cNvPicPr>
                <p:nvPr/>
              </p:nvPicPr>
              <p:blipFill>
                <a:blip r:embed="rId11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78115" t="10134" r="1581" b="84302"/>
                <a:stretch>
                  <a:fillRect/>
                </a:stretch>
              </p:blipFill>
              <p:spPr>
                <a:xfrm>
                  <a:off x="6012160" y="1318734"/>
                  <a:ext cx="1035538" cy="144016"/>
                </a:xfrm>
                <a:prstGeom prst="rect">
                  <a:avLst/>
                </a:prstGeom>
              </p:spPr>
            </p:pic>
          </p:grpSp>
          <p:sp>
            <p:nvSpPr>
              <p:cNvPr id="107" name="CaixaDeTexto 7"/>
              <p:cNvSpPr txBox="1"/>
              <p:nvPr/>
            </p:nvSpPr>
            <p:spPr>
              <a:xfrm>
                <a:off x="670847" y="3228558"/>
                <a:ext cx="30707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 smtClean="0"/>
                  <a:t>B</a:t>
                </a:r>
                <a:endParaRPr lang="en-US" sz="2400" b="1" dirty="0"/>
              </a:p>
            </p:txBody>
          </p:sp>
          <p:sp>
            <p:nvSpPr>
              <p:cNvPr id="108" name="CaixaDeTexto 13"/>
              <p:cNvSpPr txBox="1"/>
              <p:nvPr/>
            </p:nvSpPr>
            <p:spPr>
              <a:xfrm>
                <a:off x="2403058" y="908720"/>
                <a:ext cx="88718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Ischemia</a:t>
                </a:r>
              </a:p>
            </p:txBody>
          </p:sp>
          <p:sp>
            <p:nvSpPr>
              <p:cNvPr id="109" name="CaixaDeTexto 14"/>
              <p:cNvSpPr txBox="1"/>
              <p:nvPr/>
            </p:nvSpPr>
            <p:spPr>
              <a:xfrm>
                <a:off x="3222408" y="908720"/>
                <a:ext cx="9928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Reperfusio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9251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</TotalTime>
  <Words>20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João Sebastião</dc:creator>
  <cp:lastModifiedBy>Maria João Sebastião</cp:lastModifiedBy>
  <cp:revision>16</cp:revision>
  <dcterms:created xsi:type="dcterms:W3CDTF">2019-01-08T14:28:36Z</dcterms:created>
  <dcterms:modified xsi:type="dcterms:W3CDTF">2019-01-30T14:39:22Z</dcterms:modified>
</cp:coreProperties>
</file>